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>
      <p:cViewPr varScale="1">
        <p:scale>
          <a:sx n="79" d="100"/>
          <a:sy n="79" d="100"/>
        </p:scale>
        <p:origin x="732" y="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2076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356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496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790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806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0127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06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001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085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063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962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039E6-2C6B-49C3-ABF7-63D6A0141A03}" type="datetimeFigureOut">
              <a:rPr lang="en-GB" smtClean="0"/>
              <a:t>06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4AF66-D315-4A3E-B3F4-C08C4E29D1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459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79712"/>
            <a:ext cx="6848475" cy="495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-29864" y="1331640"/>
            <a:ext cx="1481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Glyburide vs. insul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473" y="966083"/>
            <a:ext cx="2452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5 Fig – Maternal glycaemic control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016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043608"/>
            <a:ext cx="1524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Metformin vs. insul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559496"/>
            <a:ext cx="6877050" cy="697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9565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187624"/>
            <a:ext cx="1680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Metformin vs. glyburide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63" y="1666875"/>
            <a:ext cx="6772275" cy="5819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8213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8</Words>
  <Application>Microsoft Office PowerPoint</Application>
  <PresentationFormat>On-screen Show 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Jane Adkins</cp:lastModifiedBy>
  <cp:revision>7</cp:revision>
  <cp:lastPrinted>2019-07-30T07:46:58Z</cp:lastPrinted>
  <dcterms:created xsi:type="dcterms:W3CDTF">2019-07-24T12:26:47Z</dcterms:created>
  <dcterms:modified xsi:type="dcterms:W3CDTF">2019-09-06T05:28:23Z</dcterms:modified>
</cp:coreProperties>
</file>